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07600" cy="993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55600" y="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4280" y="745920"/>
            <a:ext cx="2577960" cy="3725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5560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9FC189-E72C-4759-93CE-8692A18C85AF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2114640" y="746280"/>
            <a:ext cx="2577960" cy="372564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0760" y="4721400"/>
            <a:ext cx="5445000" cy="447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スライド番号プレースホルダ 3"/>
          <p:cNvSpPr/>
          <p:nvPr/>
        </p:nvSpPr>
        <p:spPr>
          <a:xfrm>
            <a:off x="3855960" y="9441000"/>
            <a:ext cx="294948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B8E573-D0D6-481B-8691-45BACDB68041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05A62-DB92-4DDE-B22B-254D619831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3FB9D-167E-4996-A798-1C2176C979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346A4-154C-450A-8B98-87B5D14DFD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B04FC-D4BE-4823-A608-195520017F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69014-9ADF-4C06-803D-669130599C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F8CCD-ADE7-4A86-B313-38CF8053BC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A1EE2-CA0B-4E26-B01B-DE9108C0C9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ADA6E-FBB8-474A-A277-D755370BDE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0E169-8AFA-4E48-A230-F150E75A95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5B34B2-E037-4B91-935C-A81DE5856A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3CA46-59D1-4362-8985-72CD02FFD9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65ED5-218C-464F-8B83-855C4E7294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AA336B-A889-4356-8E3E-D1742030208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6"/>
          <p:cNvSpPr/>
          <p:nvPr/>
        </p:nvSpPr>
        <p:spPr>
          <a:xfrm>
            <a:off x="1273320" y="825480"/>
            <a:ext cx="3381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lement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CAGGTCAACGCTC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lement1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GAGCGTTGACCT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8"/>
          <p:cNvSpPr/>
          <p:nvPr/>
        </p:nvSpPr>
        <p:spPr>
          <a:xfrm>
            <a:off x="1273320" y="1406520"/>
            <a:ext cx="3381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1_mu01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CA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A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CTCCG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1_mu01_A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CGGAGCG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TG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9"/>
          <p:cNvSpPr/>
          <p:nvPr/>
        </p:nvSpPr>
        <p:spPr>
          <a:xfrm>
            <a:off x="1273320" y="1989000"/>
            <a:ext cx="3990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lement2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ACACGTGATGCTGTGACGC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lement2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CGCGTCACAGCATCACGTGTT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1"/>
          <p:cNvSpPr/>
          <p:nvPr/>
        </p:nvSpPr>
        <p:spPr>
          <a:xfrm>
            <a:off x="1273320" y="2571840"/>
            <a:ext cx="3990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2_mu01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AA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A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ATGCTGTGACGCGA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cRB1-E2_mu01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CGCGTCACAGCATC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A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TT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4"/>
          <p:cNvSpPr/>
          <p:nvPr/>
        </p:nvSpPr>
        <p:spPr>
          <a:xfrm>
            <a:off x="1273320" y="3154320"/>
            <a:ext cx="3533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-EcRE_S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GTCTTCGAACTCTC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-EcRE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AGAGTTCGAAGAC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5"/>
          <p:cNvSpPr/>
          <p:nvPr/>
        </p:nvSpPr>
        <p:spPr>
          <a:xfrm>
            <a:off x="1273320" y="3736800"/>
            <a:ext cx="3533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-EcRE_mu01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AACTCTC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-EcRE_mu01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AGAGTTCGA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C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7"/>
          <p:cNvSpPr/>
          <p:nvPr/>
        </p:nvSpPr>
        <p:spPr>
          <a:xfrm>
            <a:off x="1273320" y="4319640"/>
            <a:ext cx="3381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B-EcRE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GTCAACGAACC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B-EcRE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GGTTCGTTGAC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0"/>
          <p:cNvSpPr/>
          <p:nvPr/>
        </p:nvSpPr>
        <p:spPr>
          <a:xfrm>
            <a:off x="1273320" y="4902120"/>
            <a:ext cx="33811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B-EcRE_mu01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A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GAACCG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B-EcRE_mu01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GGTTCG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G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1"/>
          <p:cNvSpPr/>
          <p:nvPr/>
        </p:nvSpPr>
        <p:spPr>
          <a:xfrm>
            <a:off x="1274760" y="5483160"/>
            <a:ext cx="35334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pre-BmEcRA-EcRE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GTCAACGAACTCAC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pre-BmEcRA-EcRE_A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TGAGTTCGTTGAC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3"/>
          <p:cNvSpPr/>
          <p:nvPr/>
        </p:nvSpPr>
        <p:spPr>
          <a:xfrm>
            <a:off x="1274760" y="6066000"/>
            <a:ext cx="3533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pre-BmEcRA-EcRE_mu01_S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CGG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G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ACGAACTCAC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pre-BmEcRA-EcRE_mu01_AS CCGTGAGTTCGTT</a:t>
            </a:r>
            <a:r>
              <a:rPr b="1" lang="en-US" sz="1000" spc="-1" strike="noStrike">
                <a:solidFill>
                  <a:srgbClr val="000000"/>
                </a:solidFill>
                <a:latin typeface="Courier New"/>
              </a:rPr>
              <a:t>TC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"/>
          <p:cNvSpPr/>
          <p:nvPr/>
        </p:nvSpPr>
        <p:spPr>
          <a:xfrm>
            <a:off x="321120" y="-4680"/>
            <a:ext cx="233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ABLE S5. List of Prim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"/>
          <p:cNvSpPr/>
          <p:nvPr/>
        </p:nvSpPr>
        <p:spPr>
          <a:xfrm>
            <a:off x="1751040" y="396720"/>
            <a:ext cx="57780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Nam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"/>
          <p:cNvSpPr/>
          <p:nvPr/>
        </p:nvSpPr>
        <p:spPr>
          <a:xfrm>
            <a:off x="3040200" y="396720"/>
            <a:ext cx="1844640" cy="1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equence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(5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→ 3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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5"/>
          <p:cNvSpPr/>
          <p:nvPr/>
        </p:nvSpPr>
        <p:spPr>
          <a:xfrm>
            <a:off x="571680" y="37944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6"/>
          <p:cNvSpPr/>
          <p:nvPr/>
        </p:nvSpPr>
        <p:spPr>
          <a:xfrm>
            <a:off x="571680" y="579600"/>
            <a:ext cx="6119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7"/>
          <p:cNvSpPr/>
          <p:nvPr/>
        </p:nvSpPr>
        <p:spPr>
          <a:xfrm>
            <a:off x="404640" y="8985240"/>
            <a:ext cx="6120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6"/>
          <p:cNvSpPr/>
          <p:nvPr/>
        </p:nvSpPr>
        <p:spPr>
          <a:xfrm>
            <a:off x="686520" y="9129600"/>
            <a:ext cx="572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nderlined letters indicate restriction sites used for subcloning. Mutagenized nucleotides are bol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7"/>
          <p:cNvSpPr/>
          <p:nvPr/>
        </p:nvSpPr>
        <p:spPr>
          <a:xfrm>
            <a:off x="830160" y="595440"/>
            <a:ext cx="306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Oligo probe for BmEcRB1-element1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7"/>
          <p:cNvSpPr/>
          <p:nvPr/>
        </p:nvSpPr>
        <p:spPr>
          <a:xfrm>
            <a:off x="851040" y="1179360"/>
            <a:ext cx="357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 oligo probe for BmEcRB1-element1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7"/>
          <p:cNvSpPr/>
          <p:nvPr/>
        </p:nvSpPr>
        <p:spPr>
          <a:xfrm>
            <a:off x="830160" y="1763640"/>
            <a:ext cx="3068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Oligo probe for BmEcRB1-element2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7"/>
          <p:cNvSpPr/>
          <p:nvPr/>
        </p:nvSpPr>
        <p:spPr>
          <a:xfrm>
            <a:off x="851040" y="2346480"/>
            <a:ext cx="357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 oligo probe for BmEcRB1-element2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17"/>
          <p:cNvSpPr/>
          <p:nvPr/>
        </p:nvSpPr>
        <p:spPr>
          <a:xfrm>
            <a:off x="810720" y="2930400"/>
            <a:ext cx="282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Oligo probe for BmE75A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7"/>
          <p:cNvSpPr/>
          <p:nvPr/>
        </p:nvSpPr>
        <p:spPr>
          <a:xfrm>
            <a:off x="813240" y="3514680"/>
            <a:ext cx="332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 oligo probe for BmE75A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7"/>
          <p:cNvSpPr/>
          <p:nvPr/>
        </p:nvSpPr>
        <p:spPr>
          <a:xfrm>
            <a:off x="809280" y="4098960"/>
            <a:ext cx="275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Oligo probe for BHR3B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7"/>
          <p:cNvSpPr/>
          <p:nvPr/>
        </p:nvSpPr>
        <p:spPr>
          <a:xfrm>
            <a:off x="811800" y="4681440"/>
            <a:ext cx="325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 oligo probe for BHR3B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7"/>
          <p:cNvSpPr/>
          <p:nvPr/>
        </p:nvSpPr>
        <p:spPr>
          <a:xfrm>
            <a:off x="813240" y="5265720"/>
            <a:ext cx="306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Oligo probe for pre-BmEcRA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7"/>
          <p:cNvSpPr/>
          <p:nvPr/>
        </p:nvSpPr>
        <p:spPr>
          <a:xfrm>
            <a:off x="816120" y="5850000"/>
            <a:ext cx="357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utation oligo probe for pre-BmEcRA-EcRE in gel shift ass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7"/>
          <p:cNvSpPr/>
          <p:nvPr/>
        </p:nvSpPr>
        <p:spPr>
          <a:xfrm>
            <a:off x="830160" y="6465960"/>
            <a:ext cx="360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 sets for quantitive RT-PCR of E75 and BHR3 isoform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53"/>
          <p:cNvSpPr/>
          <p:nvPr/>
        </p:nvSpPr>
        <p:spPr>
          <a:xfrm>
            <a:off x="1289880" y="6681960"/>
            <a:ext cx="417816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rp49_F01 (forward)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CAGGCGGTTCAAGGGTCAATA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rp49_B01 (reverse)     TGCTGGGCTCTTTCCACG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_F01 (forward)     CAAGGAACGTGAACCTGAATTGC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mE75A&amp;C_B01 (reverse)   TGCAGGGCCGGTATTGTATTT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75B F01 (forward)     TCTACTAAATGTAGCTGTGACCCGCA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75B_B01 (reverse)     TGGGTACACGACCGAATCG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mE75C_F01 (forward)     CCATCCCCGATTTAGAATTTGA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HR3B_F01</a:t>
            </a:r>
            <a:r>
              <a:rPr b="0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　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(forward)     CTGCATCAGCAGTCGCTTCC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BHR3B_B01  (reverse)     CCCATTTGATTGTGCATCCCGA </a:t>
            </a:r>
            <a:r>
              <a:rPr b="0" lang="ja-JP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　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7"/>
          <p:cNvSpPr/>
          <p:nvPr/>
        </p:nvSpPr>
        <p:spPr>
          <a:xfrm>
            <a:off x="853920" y="8121600"/>
            <a:ext cx="25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Primer sets for RT-PCR of BHR3 isoform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53"/>
          <p:cNvSpPr/>
          <p:nvPr/>
        </p:nvSpPr>
        <p:spPr>
          <a:xfrm>
            <a:off x="1288080" y="8337600"/>
            <a:ext cx="3838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A_F01 (forward)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CCAACATGGTGAACATGTTTG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B_F02 (forward)      CGTACGATGGATAACAACCAGT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BHR3_B01  (reverse)      TTATCCGTGCGTGTAATCTA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9T11:11:12Z</dcterms:created>
  <dc:creator>白井博之</dc:creator>
  <dc:description/>
  <dc:language>en-US</dc:language>
  <cp:lastModifiedBy> </cp:lastModifiedBy>
  <dcterms:modified xsi:type="dcterms:W3CDTF">2012-05-17T06:13:44Z</dcterms:modified>
  <cp:revision>22</cp:revision>
  <dc:subject/>
  <dc:title>スライド 1</dc:title>
</cp:coreProperties>
</file>